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enthil-Kumar Muthappa" initials="SM" lastIdx="3" clrIdx="0"/>
  <p:cmAuthor id="1" name="Ramegowda" initials="HV" lastIdx="4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8413" autoAdjust="0"/>
  </p:normalViewPr>
  <p:slideViewPr>
    <p:cSldViewPr>
      <p:cViewPr varScale="1">
        <p:scale>
          <a:sx n="56" d="100"/>
          <a:sy n="56" d="100"/>
        </p:scale>
        <p:origin x="2202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74D527-8677-458D-A945-C626A075FFA4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EFCBC5-5A49-491A-B23C-DB83C0BBEA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506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Picture 9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94" r="14734" b="15996"/>
          <a:stretch>
            <a:fillRect/>
          </a:stretch>
        </p:blipFill>
        <p:spPr>
          <a:xfrm>
            <a:off x="4267200" y="1608160"/>
            <a:ext cx="520885" cy="677840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4967289" y="3181158"/>
            <a:ext cx="1115529" cy="523220"/>
          </a:xfrm>
          <a:prstGeom prst="rect">
            <a:avLst/>
          </a:pr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collection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 flipV="1">
            <a:off x="1676400" y="804336"/>
            <a:ext cx="1" cy="795864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rot="5400000" flipH="1" flipV="1">
            <a:off x="2360613" y="1157288"/>
            <a:ext cx="790575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V="1">
            <a:off x="3657600" y="762001"/>
            <a:ext cx="0" cy="761999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/>
          <p:nvPr/>
        </p:nvCxnSpPr>
        <p:spPr>
          <a:xfrm rot="5400000" flipH="1" flipV="1">
            <a:off x="4150982" y="1138237"/>
            <a:ext cx="771525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/>
          <p:nvPr/>
        </p:nvCxnSpPr>
        <p:spPr>
          <a:xfrm>
            <a:off x="3519490" y="3399578"/>
            <a:ext cx="900110" cy="2942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3595690" y="3475778"/>
            <a:ext cx="1447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hogen + Drought</a:t>
            </a:r>
            <a:endParaRPr lang="en-I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 rot="16200000">
            <a:off x="967175" y="960135"/>
            <a:ext cx="9334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5 days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 rot="16200000">
            <a:off x="1780036" y="741036"/>
            <a:ext cx="11275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rought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5 days water with-holding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 rot="16200000">
            <a:off x="2584967" y="860168"/>
            <a:ext cx="12675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200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 days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 rot="16200000">
            <a:off x="3736647" y="952501"/>
            <a:ext cx="1170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ld (4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 2 h) 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 rot="16200000">
            <a:off x="4658135" y="779136"/>
            <a:ext cx="12037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xidative stress (5 µm MV 12 h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90" y="4447401"/>
            <a:ext cx="719038" cy="684884"/>
          </a:xfrm>
          <a:prstGeom prst="rect">
            <a:avLst/>
          </a:prstGeom>
        </p:spPr>
      </p:pic>
      <p:pic>
        <p:nvPicPr>
          <p:cNvPr id="78" name="Picture 7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5387" y="1611049"/>
            <a:ext cx="862013" cy="743817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6218" y="1576023"/>
            <a:ext cx="675619" cy="703888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036" y="1600353"/>
            <a:ext cx="798962" cy="761012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7537" y="1593940"/>
            <a:ext cx="815964" cy="777206"/>
          </a:xfrm>
          <a:prstGeom prst="rect">
            <a:avLst/>
          </a:prstGeom>
        </p:spPr>
      </p:pic>
      <p:sp>
        <p:nvSpPr>
          <p:cNvPr id="72" name="Flowchart: Magnetic Disk 71"/>
          <p:cNvSpPr/>
          <p:nvPr/>
        </p:nvSpPr>
        <p:spPr>
          <a:xfrm>
            <a:off x="4114800" y="1578592"/>
            <a:ext cx="838201" cy="838199"/>
          </a:xfrm>
          <a:prstGeom prst="flowChartMagneticDisk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27653" y="6651955"/>
            <a:ext cx="659245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Protocol for individual and combined stress imposition in sunflower. Sunflower plants were exposed to A) independent stress (n=3)  and, B) combined stress for drought and pathogen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drought + pathogen combined) and all stress (ii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hogen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rought, cold and methy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olog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MV) stress combin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(n=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For pathogen treatment, plants were expos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lasmopara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lstedi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omycete that cause downy mildew disease by growing the plants in the pathogen infected field (‘sick plot’ at GKVK Bangalore, n=3). The naturally infected leaf were rubbed to treat the new leaves.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te: Focus in the manuscript is mainly on the drought plus pathogen combined stress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Combination of all stresses (ii) data is presented only in Fig 4 and Fig S8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219200" y="256401"/>
            <a:ext cx="4572000" cy="276999"/>
          </a:xfrm>
          <a:prstGeom prst="rect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collection</a:t>
            </a:r>
          </a:p>
        </p:txBody>
      </p:sp>
      <p:cxnSp>
        <p:nvCxnSpPr>
          <p:cNvPr id="67" name="Straight Arrow Connector 66"/>
          <p:cNvCxnSpPr/>
          <p:nvPr/>
        </p:nvCxnSpPr>
        <p:spPr>
          <a:xfrm rot="5400000" flipH="1" flipV="1">
            <a:off x="5189538" y="1166038"/>
            <a:ext cx="771525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2605090" y="3743847"/>
            <a:ext cx="121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 days of water withholding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1" t="1607" r="-9611" b="-5305"/>
          <a:stretch/>
        </p:blipFill>
        <p:spPr>
          <a:xfrm>
            <a:off x="2605090" y="3094778"/>
            <a:ext cx="705929" cy="685800"/>
          </a:xfrm>
          <a:prstGeom prst="rect">
            <a:avLst/>
          </a:prstGeom>
        </p:spPr>
      </p:pic>
      <p:sp>
        <p:nvSpPr>
          <p:cNvPr id="88" name="TextBox 87"/>
          <p:cNvSpPr txBox="1"/>
          <p:nvPr/>
        </p:nvSpPr>
        <p:spPr>
          <a:xfrm>
            <a:off x="14290" y="5209401"/>
            <a:ext cx="914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 day old pla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950599" y="3746809"/>
            <a:ext cx="16267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 spore inoculation (3 days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Picture 9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90" y="3101352"/>
            <a:ext cx="713097" cy="679226"/>
          </a:xfrm>
          <a:prstGeom prst="rect">
            <a:avLst/>
          </a:prstGeom>
        </p:spPr>
      </p:pic>
      <p:cxnSp>
        <p:nvCxnSpPr>
          <p:cNvPr id="99" name="Straight Arrow Connector 98"/>
          <p:cNvCxnSpPr/>
          <p:nvPr/>
        </p:nvCxnSpPr>
        <p:spPr>
          <a:xfrm>
            <a:off x="1995490" y="3399578"/>
            <a:ext cx="4572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>
            <a:off x="623890" y="4904601"/>
            <a:ext cx="293370" cy="22604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3630033" y="5116360"/>
            <a:ext cx="561975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V="1">
            <a:off x="4811132" y="5102073"/>
            <a:ext cx="533400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rot="5400000" flipH="1" flipV="1">
            <a:off x="5486342" y="4205351"/>
            <a:ext cx="638301" cy="0"/>
          </a:xfrm>
          <a:prstGeom prst="straightConnector1">
            <a:avLst/>
          </a:prstGeom>
          <a:ln w="158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961930" y="5325969"/>
            <a:ext cx="9298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 inoculation(3 days) 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933700" y="5297269"/>
            <a:ext cx="1104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 days of water withholding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783055" y="5318766"/>
            <a:ext cx="12649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200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 day after pathogen infection 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344532" y="5345529"/>
            <a:ext cx="8906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 µm MV spray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4360969" y="4125374"/>
            <a:ext cx="1295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+S+C+D+ MV</a:t>
            </a:r>
            <a:endParaRPr lang="en-I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891" y="4666303"/>
            <a:ext cx="713097" cy="679226"/>
          </a:xfrm>
          <a:prstGeom prst="rect">
            <a:avLst/>
          </a:prstGeom>
        </p:spPr>
      </p:pic>
      <p:cxnSp>
        <p:nvCxnSpPr>
          <p:cNvPr id="29" name="Straight Arrow Connector 28"/>
          <p:cNvCxnSpPr/>
          <p:nvPr/>
        </p:nvCxnSpPr>
        <p:spPr>
          <a:xfrm rot="5400000" flipH="1" flipV="1">
            <a:off x="510196" y="3771294"/>
            <a:ext cx="565427" cy="338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593" y="4583173"/>
            <a:ext cx="711376" cy="741140"/>
          </a:xfrm>
          <a:prstGeom prst="rect">
            <a:avLst/>
          </a:prstGeom>
        </p:spPr>
      </p:pic>
      <p:cxnSp>
        <p:nvCxnSpPr>
          <p:cNvPr id="34" name="Straight Arrow Connector 33"/>
          <p:cNvCxnSpPr/>
          <p:nvPr/>
        </p:nvCxnSpPr>
        <p:spPr>
          <a:xfrm>
            <a:off x="1620257" y="5090166"/>
            <a:ext cx="4572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Picture 3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4657" y="4556766"/>
            <a:ext cx="235633" cy="214279"/>
          </a:xfrm>
          <a:prstGeom prst="rect">
            <a:avLst/>
          </a:prstGeom>
        </p:spPr>
      </p:pic>
      <p:pic>
        <p:nvPicPr>
          <p:cNvPr id="76" name="Picture 7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1" t="1607" r="-9611" b="-5305"/>
          <a:stretch/>
        </p:blipFill>
        <p:spPr>
          <a:xfrm>
            <a:off x="3034819" y="4572899"/>
            <a:ext cx="705929" cy="68580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5450" y="4583245"/>
            <a:ext cx="644136" cy="801219"/>
          </a:xfrm>
          <a:prstGeom prst="rect">
            <a:avLst/>
          </a:prstGeom>
        </p:spPr>
      </p:pic>
      <p:grpSp>
        <p:nvGrpSpPr>
          <p:cNvPr id="3" name="Group 55"/>
          <p:cNvGrpSpPr/>
          <p:nvPr/>
        </p:nvGrpSpPr>
        <p:grpSpPr>
          <a:xfrm>
            <a:off x="4006081" y="4572899"/>
            <a:ext cx="1369369" cy="1115199"/>
            <a:chOff x="3081237" y="4174867"/>
            <a:chExt cx="1369369" cy="1115199"/>
          </a:xfrm>
          <a:noFill/>
        </p:grpSpPr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94"/>
            <a:stretch>
              <a:fillRect/>
            </a:stretch>
          </p:blipFill>
          <p:spPr>
            <a:xfrm>
              <a:off x="3386038" y="4273393"/>
              <a:ext cx="518940" cy="661333"/>
            </a:xfrm>
            <a:prstGeom prst="rect">
              <a:avLst/>
            </a:prstGeom>
            <a:grpFill/>
          </p:spPr>
        </p:pic>
        <p:sp>
          <p:nvSpPr>
            <p:cNvPr id="42" name="Flowchart: Magnetic Disk 41"/>
            <p:cNvSpPr/>
            <p:nvPr/>
          </p:nvSpPr>
          <p:spPr>
            <a:xfrm>
              <a:off x="3293919" y="4174867"/>
              <a:ext cx="721056" cy="838200"/>
            </a:xfrm>
            <a:prstGeom prst="flowChartMagneticDisk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081237" y="5013067"/>
              <a:ext cx="1369369" cy="276999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d (2 h @ 4</a:t>
              </a:r>
              <a:r>
                <a:rPr lang="en-US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) 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1" name="Straight Connector 60"/>
          <p:cNvCxnSpPr/>
          <p:nvPr/>
        </p:nvCxnSpPr>
        <p:spPr>
          <a:xfrm>
            <a:off x="3187219" y="4420499"/>
            <a:ext cx="2895600" cy="1588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685800" y="22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42890" y="296300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772992" y="38100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703204" y="5438001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i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2594047" y="5123504"/>
            <a:ext cx="5375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6491290" y="4399108"/>
            <a:ext cx="0" cy="1865325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6338890" y="2895600"/>
            <a:ext cx="0" cy="91440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 rot="5400000">
            <a:off x="6167822" y="3236851"/>
            <a:ext cx="673940" cy="2762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 days 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 rot="5400000">
            <a:off x="6372748" y="4980801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 days 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07767" y="4303039"/>
            <a:ext cx="518205" cy="554784"/>
          </a:xfrm>
          <a:prstGeom prst="rect">
            <a:avLst/>
          </a:prstGeom>
        </p:spPr>
      </p:pic>
      <p:sp>
        <p:nvSpPr>
          <p:cNvPr id="68" name="Rounded Rectangle 67"/>
          <p:cNvSpPr/>
          <p:nvPr/>
        </p:nvSpPr>
        <p:spPr>
          <a:xfrm>
            <a:off x="966790" y="4419600"/>
            <a:ext cx="5422466" cy="1844833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62" t="34420" r="13584" b="54106"/>
          <a:stretch/>
        </p:blipFill>
        <p:spPr>
          <a:xfrm rot="11020852">
            <a:off x="1555244" y="3044923"/>
            <a:ext cx="406400" cy="186267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62" t="34420" r="13584" b="54106"/>
          <a:stretch/>
        </p:blipFill>
        <p:spPr>
          <a:xfrm rot="11020852">
            <a:off x="1433415" y="4594347"/>
            <a:ext cx="406400" cy="186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8076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16</TotalTime>
  <Words>251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mu's</dc:creator>
  <cp:lastModifiedBy>Senthil-Kumar Muthappa</cp:lastModifiedBy>
  <cp:revision>174</cp:revision>
  <dcterms:created xsi:type="dcterms:W3CDTF">2006-08-16T00:00:00Z</dcterms:created>
  <dcterms:modified xsi:type="dcterms:W3CDTF">2015-08-02T05:41:09Z</dcterms:modified>
</cp:coreProperties>
</file>